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60" r:id="rId4"/>
    <p:sldId id="266" r:id="rId5"/>
    <p:sldId id="265" r:id="rId6"/>
    <p:sldId id="264" r:id="rId7"/>
    <p:sldId id="267" r:id="rId8"/>
    <p:sldId id="261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66" autoAdjust="0"/>
    <p:restoredTop sz="94660"/>
  </p:normalViewPr>
  <p:slideViewPr>
    <p:cSldViewPr snapToGrid="0">
      <p:cViewPr varScale="1">
        <p:scale>
          <a:sx n="96" d="100"/>
          <a:sy n="96" d="100"/>
        </p:scale>
        <p:origin x="68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0\west_african_sheep\admixture\Large_dataset_allBBB_runs\CV_plo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0\west_african_sheep\admixture\admixture_results_2023\African_repeat_runs_3CVplo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A$1:$A$15</c:f>
              <c:numCache>
                <c:formatCode>General</c:formatCode>
                <c:ptCount val="1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</c:numCache>
            </c:numRef>
          </c:xVal>
          <c:yVal>
            <c:numRef>
              <c:f>Sheet1!$B$1:$B$15</c:f>
              <c:numCache>
                <c:formatCode>General</c:formatCode>
                <c:ptCount val="15"/>
                <c:pt idx="0">
                  <c:v>0.73845000000000005</c:v>
                </c:pt>
                <c:pt idx="1">
                  <c:v>0.70818000000000003</c:v>
                </c:pt>
                <c:pt idx="2">
                  <c:v>0.69169999999999998</c:v>
                </c:pt>
                <c:pt idx="3">
                  <c:v>0.68164000000000002</c:v>
                </c:pt>
                <c:pt idx="4">
                  <c:v>0.67754999999999999</c:v>
                </c:pt>
                <c:pt idx="5">
                  <c:v>0.67439000000000004</c:v>
                </c:pt>
                <c:pt idx="6">
                  <c:v>0.67279999999999995</c:v>
                </c:pt>
                <c:pt idx="7">
                  <c:v>0.67237000000000002</c:v>
                </c:pt>
                <c:pt idx="8">
                  <c:v>0.67068000000000005</c:v>
                </c:pt>
                <c:pt idx="9">
                  <c:v>0.67071000000000003</c:v>
                </c:pt>
                <c:pt idx="10">
                  <c:v>0.67210999999999999</c:v>
                </c:pt>
                <c:pt idx="11">
                  <c:v>0.66891999999999996</c:v>
                </c:pt>
                <c:pt idx="12">
                  <c:v>0.66857999999999995</c:v>
                </c:pt>
                <c:pt idx="13">
                  <c:v>0.66786999999999996</c:v>
                </c:pt>
                <c:pt idx="14">
                  <c:v>0.66930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769-4590-A0AC-43A92954AD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0970144"/>
        <c:axId val="330969488"/>
      </c:scatterChart>
      <c:valAx>
        <c:axId val="3309701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0969488"/>
        <c:crosses val="autoZero"/>
        <c:crossBetween val="midCat"/>
      </c:valAx>
      <c:valAx>
        <c:axId val="330969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09701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A$1:$A$15</c:f>
              <c:numCache>
                <c:formatCode>General</c:formatCode>
                <c:ptCount val="1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</c:numCache>
            </c:numRef>
          </c:xVal>
          <c:yVal>
            <c:numRef>
              <c:f>Sheet1!$B$1:$B$15</c:f>
              <c:numCache>
                <c:formatCode>General</c:formatCode>
                <c:ptCount val="15"/>
                <c:pt idx="0">
                  <c:v>0.73519000000000001</c:v>
                </c:pt>
                <c:pt idx="1">
                  <c:v>0.70820000000000005</c:v>
                </c:pt>
                <c:pt idx="2">
                  <c:v>0.69703000000000004</c:v>
                </c:pt>
                <c:pt idx="3">
                  <c:v>0.69277</c:v>
                </c:pt>
                <c:pt idx="4">
                  <c:v>0.68830000000000002</c:v>
                </c:pt>
                <c:pt idx="5">
                  <c:v>0.68491000000000002</c:v>
                </c:pt>
                <c:pt idx="6">
                  <c:v>0.68408000000000002</c:v>
                </c:pt>
                <c:pt idx="7">
                  <c:v>0.68252000000000002</c:v>
                </c:pt>
                <c:pt idx="8">
                  <c:v>0.68208999999999997</c:v>
                </c:pt>
                <c:pt idx="9">
                  <c:v>0.68157999999999996</c:v>
                </c:pt>
                <c:pt idx="10">
                  <c:v>0.68106999999999995</c:v>
                </c:pt>
                <c:pt idx="11">
                  <c:v>0.68083000000000005</c:v>
                </c:pt>
                <c:pt idx="12">
                  <c:v>0.67967</c:v>
                </c:pt>
                <c:pt idx="13">
                  <c:v>0.67893999999999999</c:v>
                </c:pt>
                <c:pt idx="14">
                  <c:v>0.680679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D8F-474C-A6E8-8DE3D32B54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3068648"/>
        <c:axId val="423071600"/>
      </c:scatterChart>
      <c:valAx>
        <c:axId val="423068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071600"/>
        <c:crosses val="autoZero"/>
        <c:crossBetween val="midCat"/>
      </c:valAx>
      <c:valAx>
        <c:axId val="4230716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0686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10CAM_seconddegree'!$A$1:$A$10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xVal>
          <c:yVal>
            <c:numRef>
              <c:f>'10CAM_seconddegree'!$B$1:$B$10</c:f>
              <c:numCache>
                <c:formatCode>General</c:formatCode>
                <c:ptCount val="10"/>
                <c:pt idx="0">
                  <c:v>0.67486999999999997</c:v>
                </c:pt>
                <c:pt idx="1">
                  <c:v>0.65808999999999995</c:v>
                </c:pt>
                <c:pt idx="2">
                  <c:v>0.65224000000000004</c:v>
                </c:pt>
                <c:pt idx="3">
                  <c:v>0.64744000000000002</c:v>
                </c:pt>
                <c:pt idx="4">
                  <c:v>0.64903</c:v>
                </c:pt>
                <c:pt idx="5">
                  <c:v>0.64798999999999995</c:v>
                </c:pt>
                <c:pt idx="6">
                  <c:v>0.65564999999999996</c:v>
                </c:pt>
                <c:pt idx="7">
                  <c:v>0.64915999999999996</c:v>
                </c:pt>
                <c:pt idx="8">
                  <c:v>0.65676999999999996</c:v>
                </c:pt>
                <c:pt idx="9">
                  <c:v>0.66193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40C-419A-8D3D-C74FE80F3A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4065088"/>
        <c:axId val="454066728"/>
      </c:scatterChart>
      <c:valAx>
        <c:axId val="4540650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800" b="1"/>
                  <a:t>K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4066728"/>
        <c:crosses val="autoZero"/>
        <c:crossBetween val="midCat"/>
      </c:valAx>
      <c:valAx>
        <c:axId val="4540667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800" b="1" dirty="0"/>
                  <a:t>CV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406508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A$1:$A$7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xVal>
          <c:yVal>
            <c:numRef>
              <c:f>Sheet1!$B$1:$B$7</c:f>
              <c:numCache>
                <c:formatCode>General</c:formatCode>
                <c:ptCount val="7"/>
                <c:pt idx="0">
                  <c:v>0.66783000000000003</c:v>
                </c:pt>
                <c:pt idx="1">
                  <c:v>0.60963000000000001</c:v>
                </c:pt>
                <c:pt idx="2">
                  <c:v>0.60597999999999996</c:v>
                </c:pt>
                <c:pt idx="3">
                  <c:v>0.63305</c:v>
                </c:pt>
                <c:pt idx="4">
                  <c:v>0.64576</c:v>
                </c:pt>
                <c:pt idx="5">
                  <c:v>0.66722999999999999</c:v>
                </c:pt>
                <c:pt idx="6">
                  <c:v>0.70130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181-49C0-9111-8542635F56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8275136"/>
        <c:axId val="1078275552"/>
      </c:scatterChart>
      <c:valAx>
        <c:axId val="10782751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K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8275552"/>
        <c:crosses val="autoZero"/>
        <c:crossBetween val="midCat"/>
      </c:valAx>
      <c:valAx>
        <c:axId val="10782755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600"/>
                  <a:t>CV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782751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263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9584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6494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4648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9494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95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657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695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2515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2179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4550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D74B1-AA6F-4541-844F-160DA1C1EAD8}" type="datetimeFigureOut">
              <a:rPr lang="en-GB" smtClean="0"/>
              <a:t>12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05C9AF-FD75-425A-9E35-77D8EB054A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3194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5429445"/>
              </p:ext>
            </p:extLst>
          </p:nvPr>
        </p:nvGraphicFramePr>
        <p:xfrm>
          <a:off x="6903314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418114" y="4800600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K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44218" y="3244334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V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5217717"/>
              </p:ext>
            </p:extLst>
          </p:nvPr>
        </p:nvGraphicFramePr>
        <p:xfrm>
          <a:off x="1132114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878010" y="4800600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K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704114" y="3244334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V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913395" y="1332411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10 CAMSHP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033662" y="1332411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63 CAMSH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971B07-DA01-97D0-02B7-5671EAFD6ABD}"/>
              </a:ext>
            </a:extLst>
          </p:cNvPr>
          <p:cNvSpPr txBox="1"/>
          <p:nvPr/>
        </p:nvSpPr>
        <p:spPr>
          <a:xfrm>
            <a:off x="168443" y="110381"/>
            <a:ext cx="51267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 Fig S1</a:t>
            </a:r>
            <a:endParaRPr lang="en-US" dirty="0"/>
          </a:p>
          <a:p>
            <a:r>
              <a:rPr lang="en-US" dirty="0"/>
              <a:t>CV Error for Admixture analysis of global 50K datase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193774" y="609600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181634" y="609600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49224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4420A33-5BD7-CA81-C209-52E615FFFB3D}"/>
              </a:ext>
            </a:extLst>
          </p:cNvPr>
          <p:cNvSpPr txBox="1"/>
          <p:nvPr/>
        </p:nvSpPr>
        <p:spPr>
          <a:xfrm>
            <a:off x="167633" y="237524"/>
            <a:ext cx="134363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 Fig S2</a:t>
            </a:r>
            <a:endParaRPr lang="en-US" dirty="0"/>
          </a:p>
          <a:p>
            <a:r>
              <a:rPr lang="en-US" dirty="0"/>
              <a:t>Admixture</a:t>
            </a:r>
          </a:p>
          <a:p>
            <a:r>
              <a:rPr lang="en-US" dirty="0"/>
              <a:t>with</a:t>
            </a:r>
          </a:p>
          <a:p>
            <a:r>
              <a:rPr lang="en-US" dirty="0"/>
              <a:t>63 CAMSHP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2B41916-4538-4DDF-9A83-57832A103E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8131" y="104905"/>
            <a:ext cx="9004586" cy="6721339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1F1756BA-C98D-4867-AAF5-D73EC54D1110}"/>
              </a:ext>
            </a:extLst>
          </p:cNvPr>
          <p:cNvGrpSpPr/>
          <p:nvPr/>
        </p:nvGrpSpPr>
        <p:grpSpPr>
          <a:xfrm>
            <a:off x="10537727" y="154619"/>
            <a:ext cx="1486640" cy="6621910"/>
            <a:chOff x="9547124" y="104905"/>
            <a:chExt cx="1486640" cy="6621910"/>
          </a:xfrm>
        </p:grpSpPr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6F325D8D-B828-4D18-B01A-4F85D0BB02FB}"/>
                </a:ext>
              </a:extLst>
            </p:cNvPr>
            <p:cNvSpPr/>
            <p:nvPr/>
          </p:nvSpPr>
          <p:spPr>
            <a:xfrm>
              <a:off x="9547124" y="104905"/>
              <a:ext cx="393290" cy="6621910"/>
            </a:xfrm>
            <a:prstGeom prst="ellipse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3EEFFF6-9059-4B95-A721-57440DBE6FE6}"/>
                </a:ext>
              </a:extLst>
            </p:cNvPr>
            <p:cNvSpPr txBox="1"/>
            <p:nvPr/>
          </p:nvSpPr>
          <p:spPr>
            <a:xfrm>
              <a:off x="10368197" y="187810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BBBs</a:t>
              </a: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1610066E-EB27-4345-83D4-56C54EB1DAC0}"/>
                </a:ext>
              </a:extLst>
            </p:cNvPr>
            <p:cNvCxnSpPr>
              <a:cxnSpLocks/>
              <a:stCxn id="11" idx="2"/>
            </p:cNvCxnSpPr>
            <p:nvPr/>
          </p:nvCxnSpPr>
          <p:spPr>
            <a:xfrm flipH="1">
              <a:off x="9924872" y="557142"/>
              <a:ext cx="776109" cy="46657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866737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9971B07-DA01-97D0-02B7-5671EAFD6ABD}"/>
              </a:ext>
            </a:extLst>
          </p:cNvPr>
          <p:cNvSpPr txBox="1"/>
          <p:nvPr/>
        </p:nvSpPr>
        <p:spPr>
          <a:xfrm>
            <a:off x="168443" y="118770"/>
            <a:ext cx="65323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 Fig S3</a:t>
            </a:r>
          </a:p>
          <a:p>
            <a:r>
              <a:rPr lang="en-US" dirty="0"/>
              <a:t>CV Error for Admixture analysis of 50K African dataset (181 samples)</a:t>
            </a: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1248208"/>
              </p:ext>
            </p:extLst>
          </p:nvPr>
        </p:nvGraphicFramePr>
        <p:xfrm>
          <a:off x="2390775" y="1471612"/>
          <a:ext cx="7410450" cy="3914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17127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42D0E58-CB65-43EB-BB96-1A743EA66B33}"/>
              </a:ext>
            </a:extLst>
          </p:cNvPr>
          <p:cNvSpPr txBox="1"/>
          <p:nvPr/>
        </p:nvSpPr>
        <p:spPr>
          <a:xfrm>
            <a:off x="168443" y="118770"/>
            <a:ext cx="102086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 Fig S4</a:t>
            </a:r>
          </a:p>
          <a:p>
            <a:r>
              <a:rPr lang="en-GB" dirty="0"/>
              <a:t>Admixture analysis based on sub-sample of the </a:t>
            </a:r>
            <a:r>
              <a:rPr lang="en-GB" dirty="0" err="1"/>
              <a:t>global_second_degree</a:t>
            </a:r>
            <a:r>
              <a:rPr lang="en-GB" dirty="0"/>
              <a:t> dataset including only African breeds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9233EC3-D1FB-43F4-82DC-47B6B0DE30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8184593"/>
              </p:ext>
            </p:extLst>
          </p:nvPr>
        </p:nvGraphicFramePr>
        <p:xfrm>
          <a:off x="2049258" y="899088"/>
          <a:ext cx="7625684" cy="57125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Acrobat Document" r:id="rId3" imgW="5390828" imgH="4038547" progId="Acrobat.Document.DC">
                  <p:embed/>
                </p:oleObj>
              </mc:Choice>
              <mc:Fallback>
                <p:oleObj name="Acrobat Document" r:id="rId3" imgW="5390828" imgH="4038547" progId="Acrobat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49258" y="899088"/>
                        <a:ext cx="7625684" cy="57125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507367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CC17137-ED0F-4E46-B03A-2847188BDF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5789956"/>
              </p:ext>
            </p:extLst>
          </p:nvPr>
        </p:nvGraphicFramePr>
        <p:xfrm>
          <a:off x="986145" y="1817213"/>
          <a:ext cx="9844034" cy="49220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Acrobat Document" r:id="rId3" imgW="6857820" imgH="3428880" progId="Acrobat.Document.DC">
                  <p:embed/>
                </p:oleObj>
              </mc:Choice>
              <mc:Fallback>
                <p:oleObj name="Acrobat Document" r:id="rId3" imgW="6857820" imgH="3428880" progId="Acrobat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6145" y="1817213"/>
                        <a:ext cx="9844034" cy="49220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7C6FFD6-CBE9-4CCB-A485-1AFBFE629DE9}"/>
              </a:ext>
            </a:extLst>
          </p:cNvPr>
          <p:cNvSpPr txBox="1"/>
          <p:nvPr/>
        </p:nvSpPr>
        <p:spPr>
          <a:xfrm>
            <a:off x="168443" y="118770"/>
            <a:ext cx="11302646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 Fig S5</a:t>
            </a:r>
          </a:p>
          <a:p>
            <a:r>
              <a:rPr lang="en-GB" dirty="0"/>
              <a:t>PCA based on WGS data for European, West/Central African and BBB samples.</a:t>
            </a:r>
          </a:p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final dataset included 77 individuals and ~637K SNP markers. </a:t>
            </a:r>
          </a:p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reeds include Cameroon Blackbelly (“CAM”)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jallonk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“DJA”), </a:t>
            </a:r>
          </a:p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ritish (Cheviot, Scottish Blackface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llgelau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elsh Mountain, Welsh Hardy Speckled Face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egaon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elsh Mountain), </a:t>
            </a:r>
          </a:p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rino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mbouillet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other European (“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therEur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”: Milk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caun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urr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jalad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astellan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</a:t>
            </a:r>
            <a:endParaRPr lang="en-GB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583465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FC31CBA-C9D5-42DC-85A1-4F8608B1DD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362571"/>
              </p:ext>
            </p:extLst>
          </p:nvPr>
        </p:nvGraphicFramePr>
        <p:xfrm>
          <a:off x="3187429" y="1935804"/>
          <a:ext cx="5353455" cy="33998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278DED5-54D6-4138-83FE-09617499251B}"/>
              </a:ext>
            </a:extLst>
          </p:cNvPr>
          <p:cNvSpPr txBox="1"/>
          <p:nvPr/>
        </p:nvSpPr>
        <p:spPr>
          <a:xfrm>
            <a:off x="122360" y="210425"/>
            <a:ext cx="43769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 Fig S6</a:t>
            </a:r>
          </a:p>
          <a:p>
            <a:r>
              <a:rPr lang="en-US" dirty="0"/>
              <a:t>CV Error for Admixture analysis of  </a:t>
            </a:r>
            <a:r>
              <a:rPr lang="en-GB" dirty="0"/>
              <a:t>WGS data</a:t>
            </a:r>
          </a:p>
        </p:txBody>
      </p:sp>
    </p:spTree>
    <p:extLst>
      <p:ext uri="{BB962C8B-B14F-4D97-AF65-F5344CB8AC3E}">
        <p14:creationId xmlns:p14="http://schemas.microsoft.com/office/powerpoint/2010/main" val="10127099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289A279-3F16-4A51-B289-1A24ED35F1AA}"/>
              </a:ext>
            </a:extLst>
          </p:cNvPr>
          <p:cNvSpPr txBox="1"/>
          <p:nvPr/>
        </p:nvSpPr>
        <p:spPr>
          <a:xfrm>
            <a:off x="294967" y="218456"/>
            <a:ext cx="94586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Supp Fig S7. </a:t>
            </a:r>
            <a:r>
              <a:rPr lang="en-GB" dirty="0" err="1"/>
              <a:t>Neighbor</a:t>
            </a:r>
            <a:r>
              <a:rPr lang="en-GB" dirty="0"/>
              <a:t>-Net relationships based on WGS data (see Supp Fig S5 for further details)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B416B50-14FC-45C2-AA8A-B1D5215AA80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9032" y="864787"/>
            <a:ext cx="10137058" cy="5677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24925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E0341D9-D743-4F67-99F5-3297BC301C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047750"/>
            <a:ext cx="4762500" cy="47625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0BF72DD-71FE-4BCE-9DA6-4E042AB48CFC}"/>
              </a:ext>
            </a:extLst>
          </p:cNvPr>
          <p:cNvSpPr txBox="1"/>
          <p:nvPr/>
        </p:nvSpPr>
        <p:spPr>
          <a:xfrm>
            <a:off x="168443" y="101992"/>
            <a:ext cx="241566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 Fig S8</a:t>
            </a:r>
          </a:p>
          <a:p>
            <a:r>
              <a:rPr lang="en-GB" dirty="0"/>
              <a:t>LD on OAR3 (WGS data)</a:t>
            </a:r>
          </a:p>
          <a:p>
            <a:r>
              <a:rPr lang="en-GB" dirty="0"/>
              <a:t>mean </a:t>
            </a:r>
            <a:r>
              <a:rPr lang="en-GB" i="1" dirty="0"/>
              <a:t>r</a:t>
            </a:r>
            <a:r>
              <a:rPr lang="en-GB" baseline="30000" dirty="0"/>
              <a:t>2</a:t>
            </a:r>
            <a:r>
              <a:rPr lang="en-GB" dirty="0"/>
              <a:t>, with 95% CI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9099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197</Words>
  <Application>Microsoft Office PowerPoint</Application>
  <PresentationFormat>Widescreen</PresentationFormat>
  <Paragraphs>35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Acrobat 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m Wiener</dc:creator>
  <cp:lastModifiedBy>Pam Wiener</cp:lastModifiedBy>
  <cp:revision>24</cp:revision>
  <dcterms:created xsi:type="dcterms:W3CDTF">2023-08-14T15:40:56Z</dcterms:created>
  <dcterms:modified xsi:type="dcterms:W3CDTF">2025-05-12T12:14:15Z</dcterms:modified>
</cp:coreProperties>
</file>